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7" r:id="rId2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C17F8"/>
    <a:srgbClr val="4B76FF"/>
    <a:srgbClr val="FF4343"/>
    <a:srgbClr val="50FF19"/>
    <a:srgbClr val="FF0066"/>
  </p:clrMru>
  <p:extLst>
    <p:ext uri="{E76CE94A-603C-4142-B9EB-6D1370010A27}">
      <p14:discardImageEditData xmlns:p14="http://schemas.microsoft.com/office/powerpoint/2010/main" val="1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74874" autoAdjust="0"/>
  </p:normalViewPr>
  <p:slideViewPr>
    <p:cSldViewPr snapToGrid="0">
      <p:cViewPr>
        <p:scale>
          <a:sx n="95" d="100"/>
          <a:sy n="95" d="100"/>
        </p:scale>
        <p:origin x="278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kizaki satoru" userId="c4948fec-e96c-4c67-b6e6-2460f4ee40c5" providerId="ADAL" clId="{11863B37-CD33-4F0F-9F32-CB77916FC08B}"/>
    <pc:docChg chg="modSld">
      <pc:chgData name="kakizaki satoru" userId="c4948fec-e96c-4c67-b6e6-2460f4ee40c5" providerId="ADAL" clId="{11863B37-CD33-4F0F-9F32-CB77916FC08B}" dt="2024-11-14T02:07:30.399" v="1" actId="20577"/>
      <pc:docMkLst>
        <pc:docMk/>
      </pc:docMkLst>
      <pc:sldChg chg="modSp mod">
        <pc:chgData name="kakizaki satoru" userId="c4948fec-e96c-4c67-b6e6-2460f4ee40c5" providerId="ADAL" clId="{11863B37-CD33-4F0F-9F32-CB77916FC08B}" dt="2024-11-14T02:07:30.399" v="1" actId="20577"/>
        <pc:sldMkLst>
          <pc:docMk/>
          <pc:sldMk cId="1160370529" sldId="287"/>
        </pc:sldMkLst>
        <pc:spChg chg="mod">
          <ac:chgData name="kakizaki satoru" userId="c4948fec-e96c-4c67-b6e6-2460f4ee40c5" providerId="ADAL" clId="{11863B37-CD33-4F0F-9F32-CB77916FC08B}" dt="2024-11-14T02:07:30.399" v="1" actId="20577"/>
          <ac:spMkLst>
            <pc:docMk/>
            <pc:sldMk cId="1160370529" sldId="287"/>
            <ac:spMk id="39" creationId="{C69B15B0-804E-466F-BAC5-95CF962D8E07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解析!$C$11</c:f>
              <c:strCache>
                <c:ptCount val="1"/>
                <c:pt idx="0">
                  <c:v>Patients %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480A-4192-86C0-C2F22CD183D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DE9-4CEA-BD94-B210048F06DA}"/>
              </c:ext>
            </c:extLst>
          </c:dPt>
          <c:cat>
            <c:strRef>
              <c:f>解析!$D$6:$E$6</c:f>
              <c:strCache>
                <c:ptCount val="2"/>
                <c:pt idx="0">
                  <c:v>Child A</c:v>
                </c:pt>
                <c:pt idx="1">
                  <c:v>Child B or C</c:v>
                </c:pt>
              </c:strCache>
            </c:strRef>
          </c:cat>
          <c:val>
            <c:numRef>
              <c:f>解析!$D$11:$E$11</c:f>
              <c:numCache>
                <c:formatCode>General</c:formatCode>
                <c:ptCount val="2"/>
                <c:pt idx="0">
                  <c:v>91.666666666666657</c:v>
                </c:pt>
                <c:pt idx="1">
                  <c:v>70.5882352941176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DE9-4CEA-BD94-B210048F06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79197424"/>
        <c:axId val="479195984"/>
      </c:barChart>
      <c:catAx>
        <c:axId val="479197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79195984"/>
        <c:crosses val="autoZero"/>
        <c:auto val="1"/>
        <c:lblAlgn val="ctr"/>
        <c:lblOffset val="100"/>
        <c:noMultiLvlLbl val="0"/>
      </c:catAx>
      <c:valAx>
        <c:axId val="479195984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b="1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  <a:r>
                  <a:rPr lang="en-US" altLang="ja-JP" b="1" baseline="0">
                    <a:latin typeface="Arial" panose="020B0604020202020204" pitchFamily="34" charset="0"/>
                    <a:cs typeface="Arial" panose="020B0604020202020204" pitchFamily="34" charset="0"/>
                  </a:rPr>
                  <a:t> (%)</a:t>
                </a:r>
                <a:endParaRPr lang="ja-JP" altLang="en-US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791974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解析!$C$11</c:f>
              <c:strCache>
                <c:ptCount val="1"/>
                <c:pt idx="0">
                  <c:v>Patients %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BE58-4EC0-9EFA-B45E4F3719CC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D760-4870-A641-71BE050E0A97}"/>
              </c:ext>
            </c:extLst>
          </c:dPt>
          <c:cat>
            <c:strRef>
              <c:f>解析!$D$6:$E$6</c:f>
              <c:strCache>
                <c:ptCount val="2"/>
                <c:pt idx="0">
                  <c:v>Child A</c:v>
                </c:pt>
                <c:pt idx="1">
                  <c:v>Child B or C
</c:v>
                </c:pt>
              </c:strCache>
            </c:strRef>
          </c:cat>
          <c:val>
            <c:numRef>
              <c:f>解析!$D$11:$E$11</c:f>
              <c:numCache>
                <c:formatCode>General</c:formatCode>
                <c:ptCount val="2"/>
                <c:pt idx="0">
                  <c:v>80.555555555555557</c:v>
                </c:pt>
                <c:pt idx="1">
                  <c:v>67.647058823529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760-4870-A641-71BE050E0A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79197424"/>
        <c:axId val="479195984"/>
      </c:barChart>
      <c:catAx>
        <c:axId val="479197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79195984"/>
        <c:crosses val="autoZero"/>
        <c:auto val="1"/>
        <c:lblAlgn val="ctr"/>
        <c:lblOffset val="100"/>
        <c:noMultiLvlLbl val="0"/>
      </c:catAx>
      <c:valAx>
        <c:axId val="479195984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b="1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  <a:r>
                  <a:rPr lang="en-US" altLang="ja-JP" b="1" baseline="0">
                    <a:latin typeface="Arial" panose="020B0604020202020204" pitchFamily="34" charset="0"/>
                    <a:cs typeface="Arial" panose="020B0604020202020204" pitchFamily="34" charset="0"/>
                  </a:rPr>
                  <a:t> (%)</a:t>
                </a:r>
                <a:endParaRPr lang="ja-JP" altLang="en-US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791974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698D-49CE-B5DF-229C97D1ACB6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FED-49AD-AB05-FCDF5FAD65C8}"/>
              </c:ext>
            </c:extLst>
          </c:dPt>
          <c:errBars>
            <c:errBarType val="both"/>
            <c:errValType val="cust"/>
            <c:noEndCap val="0"/>
            <c:plus>
              <c:numRef>
                <c:f>解析!$D$8:$E$8</c:f>
                <c:numCache>
                  <c:formatCode>General</c:formatCode>
                  <c:ptCount val="2"/>
                  <c:pt idx="0">
                    <c:v>1.9626920000000001</c:v>
                  </c:pt>
                  <c:pt idx="1">
                    <c:v>2.1332460000000002</c:v>
                  </c:pt>
                </c:numCache>
              </c:numRef>
            </c:plus>
            <c:minus>
              <c:numRef>
                <c:f>解析!$D$8:$E$8</c:f>
                <c:numCache>
                  <c:formatCode>General</c:formatCode>
                  <c:ptCount val="2"/>
                  <c:pt idx="0">
                    <c:v>1.9626920000000001</c:v>
                  </c:pt>
                  <c:pt idx="1">
                    <c:v>2.1332460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解析!$D$6:$E$6</c:f>
              <c:strCache>
                <c:ptCount val="2"/>
                <c:pt idx="0">
                  <c:v>Child A</c:v>
                </c:pt>
                <c:pt idx="1">
                  <c:v>Child B or C</c:v>
                </c:pt>
              </c:strCache>
            </c:strRef>
          </c:cat>
          <c:val>
            <c:numRef>
              <c:f>解析!$D$7:$E$7</c:f>
              <c:numCache>
                <c:formatCode>General</c:formatCode>
                <c:ptCount val="2"/>
                <c:pt idx="0">
                  <c:v>2.661111</c:v>
                </c:pt>
                <c:pt idx="1">
                  <c:v>2.332352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FED-49AD-AB05-FCDF5FAD65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79197424"/>
        <c:axId val="479195984"/>
      </c:barChart>
      <c:catAx>
        <c:axId val="479197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79195984"/>
        <c:crosses val="autoZero"/>
        <c:auto val="1"/>
        <c:lblAlgn val="ctr"/>
        <c:lblOffset val="100"/>
        <c:noMultiLvlLbl val="0"/>
      </c:catAx>
      <c:valAx>
        <c:axId val="479195984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b="1" baseline="0">
                    <a:latin typeface="Arial" panose="020B0604020202020204" pitchFamily="34" charset="0"/>
                    <a:cs typeface="Arial" panose="020B0604020202020204" pitchFamily="34" charset="0"/>
                  </a:rPr>
                  <a:t>Platelet count change  (×10000)</a:t>
                </a:r>
                <a:endParaRPr lang="ja-JP" altLang="en-US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791974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解析!$C$6</c:f>
              <c:strCache>
                <c:ptCount val="1"/>
                <c:pt idx="0">
                  <c:v>Child A</c:v>
                </c:pt>
              </c:strCache>
            </c:strRef>
          </c:tx>
          <c:spPr>
            <a:ln w="19050" cap="rnd">
              <a:solidFill>
                <a:schemeClr val="bg1">
                  <a:lumMod val="75000"/>
                  <a:alpha val="97000"/>
                </a:schemeClr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75000"/>
                </a:schemeClr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解析!$D$13:$G$13</c:f>
                <c:numCache>
                  <c:formatCode>General</c:formatCode>
                  <c:ptCount val="4"/>
                  <c:pt idx="0">
                    <c:v>0.58162334399997662</c:v>
                  </c:pt>
                  <c:pt idx="1">
                    <c:v>1.3409654752442761</c:v>
                  </c:pt>
                  <c:pt idx="2">
                    <c:v>2.0513100730686733</c:v>
                  </c:pt>
                  <c:pt idx="3">
                    <c:v>1.8640237700696287</c:v>
                  </c:pt>
                </c:numCache>
              </c:numRef>
            </c:plus>
            <c:minus>
              <c:numRef>
                <c:f>解析!$D$13:$G$13</c:f>
                <c:numCache>
                  <c:formatCode>General</c:formatCode>
                  <c:ptCount val="4"/>
                  <c:pt idx="0">
                    <c:v>0.58162334399997662</c:v>
                  </c:pt>
                  <c:pt idx="1">
                    <c:v>1.3409654752442761</c:v>
                  </c:pt>
                  <c:pt idx="2">
                    <c:v>2.0513100730686733</c:v>
                  </c:pt>
                  <c:pt idx="3">
                    <c:v>1.86402377006962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1">
                    <a:lumMod val="75000"/>
                  </a:schemeClr>
                </a:solidFill>
                <a:prstDash val="solid"/>
                <a:round/>
              </a:ln>
              <a:effectLst/>
            </c:spPr>
          </c:errBars>
          <c:xVal>
            <c:numRef>
              <c:f>解析!$D$5:$G$5</c:f>
              <c:numCache>
                <c:formatCode>General</c:formatCode>
                <c:ptCount val="4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8</c:v>
                </c:pt>
              </c:numCache>
            </c:numRef>
          </c:xVal>
          <c:yVal>
            <c:numRef>
              <c:f>解析!$D$6:$G$6</c:f>
              <c:numCache>
                <c:formatCode>General</c:formatCode>
                <c:ptCount val="4"/>
                <c:pt idx="0">
                  <c:v>4.083333333333333</c:v>
                </c:pt>
                <c:pt idx="1">
                  <c:v>5.1083333333333325</c:v>
                </c:pt>
                <c:pt idx="2">
                  <c:v>6.7111111111111121</c:v>
                </c:pt>
                <c:pt idx="3">
                  <c:v>6.85384615384615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762-414D-BFC5-495A21023AA4}"/>
            </c:ext>
          </c:extLst>
        </c:ser>
        <c:ser>
          <c:idx val="1"/>
          <c:order val="1"/>
          <c:tx>
            <c:strRef>
              <c:f>解析!$C$7</c:f>
              <c:strCache>
                <c:ptCount val="1"/>
                <c:pt idx="0">
                  <c:v>Child B or C</c:v>
                </c:pt>
              </c:strCache>
            </c:strRef>
          </c:tx>
          <c:spPr>
            <a:ln w="19050" cap="rnd" cmpd="sng">
              <a:solidFill>
                <a:schemeClr val="tx1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解析!$D$14:$G$14</c:f>
                <c:numCache>
                  <c:formatCode>General</c:formatCode>
                  <c:ptCount val="4"/>
                  <c:pt idx="0">
                    <c:v>0.89839924984452868</c:v>
                  </c:pt>
                  <c:pt idx="1">
                    <c:v>1.9206480387850557</c:v>
                  </c:pt>
                  <c:pt idx="2">
                    <c:v>2.4038757327125735</c:v>
                  </c:pt>
                  <c:pt idx="3">
                    <c:v>3.6908309814096483</c:v>
                  </c:pt>
                </c:numCache>
              </c:numRef>
            </c:plus>
            <c:minus>
              <c:numRef>
                <c:f>解析!$D$14:$G$14</c:f>
                <c:numCache>
                  <c:formatCode>General</c:formatCode>
                  <c:ptCount val="4"/>
                  <c:pt idx="0">
                    <c:v>0.89839924984452868</c:v>
                  </c:pt>
                  <c:pt idx="1">
                    <c:v>1.9206480387850557</c:v>
                  </c:pt>
                  <c:pt idx="2">
                    <c:v>2.4038757327125735</c:v>
                  </c:pt>
                  <c:pt idx="3">
                    <c:v>3.69083098140964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xVal>
            <c:numRef>
              <c:f>解析!$D$5:$G$5</c:f>
              <c:numCache>
                <c:formatCode>General</c:formatCode>
                <c:ptCount val="4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8</c:v>
                </c:pt>
              </c:numCache>
            </c:numRef>
          </c:xVal>
          <c:yVal>
            <c:numRef>
              <c:f>解析!$D$7:$G$7</c:f>
              <c:numCache>
                <c:formatCode>General</c:formatCode>
                <c:ptCount val="4"/>
                <c:pt idx="0">
                  <c:v>3.75</c:v>
                </c:pt>
                <c:pt idx="1">
                  <c:v>5.0000000000000009</c:v>
                </c:pt>
                <c:pt idx="2">
                  <c:v>5.9676470588235304</c:v>
                </c:pt>
                <c:pt idx="3">
                  <c:v>6.68400000000000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762-414D-BFC5-495A21023A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4389432"/>
        <c:axId val="634390872"/>
      </c:scatterChart>
      <c:valAx>
        <c:axId val="6343894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4390872"/>
        <c:crosses val="autoZero"/>
        <c:crossBetween val="midCat"/>
        <c:majorUnit val="5"/>
      </c:valAx>
      <c:valAx>
        <c:axId val="6343908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latelet count (×10000)</a:t>
                </a:r>
                <a:endParaRPr lang="ja-JP" altLang="en-US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4389432"/>
        <c:crosses val="autoZero"/>
        <c:crossBetween val="midCat"/>
        <c:majorUnit val="1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21672009784987764"/>
          <c:y val="3.7192460317460319E-2"/>
          <c:w val="0.34238702201622245"/>
          <c:h val="0.1195673740510697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69572D-DE93-4534-A293-4B058188293E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E700A6-2632-4E6C-8DBE-11ABD168A8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38090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43138" y="1243013"/>
            <a:ext cx="2320925" cy="3354387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DF8107-3712-4D8C-96B0-2D56D56CB96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56715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6926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1114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9920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2874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3007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2928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350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2845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9717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4020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6843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6748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6BA904D2-6FC7-44BC-A4B1-62DD98B08E92}"/>
              </a:ext>
            </a:extLst>
          </p:cNvPr>
          <p:cNvSpPr txBox="1"/>
          <p:nvPr/>
        </p:nvSpPr>
        <p:spPr>
          <a:xfrm>
            <a:off x="179294" y="475163"/>
            <a:ext cx="2057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Box 96">
            <a:extLst>
              <a:ext uri="{FF2B5EF4-FFF2-40B4-BE49-F238E27FC236}">
                <a16:creationId xmlns:a16="http://schemas.microsoft.com/office/drawing/2014/main" id="{C69B15B0-804E-466F-BAC5-95CF962D8E07}"/>
              </a:ext>
            </a:extLst>
          </p:cNvPr>
          <p:cNvSpPr txBox="1"/>
          <p:nvPr/>
        </p:nvSpPr>
        <p:spPr>
          <a:xfrm>
            <a:off x="0" y="0"/>
            <a:ext cx="29209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83107B2-D4FC-876C-A79B-9C3ADEC6CC66}"/>
              </a:ext>
            </a:extLst>
          </p:cNvPr>
          <p:cNvSpPr txBox="1"/>
          <p:nvPr/>
        </p:nvSpPr>
        <p:spPr>
          <a:xfrm>
            <a:off x="3429000" y="475163"/>
            <a:ext cx="2057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5612CAA-2BA1-BA1A-C267-B1024F5484C3}"/>
              </a:ext>
            </a:extLst>
          </p:cNvPr>
          <p:cNvSpPr txBox="1"/>
          <p:nvPr/>
        </p:nvSpPr>
        <p:spPr>
          <a:xfrm>
            <a:off x="185823" y="3299728"/>
            <a:ext cx="2057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14FD12B-7597-C698-1EBB-C0B8B2DD5D14}"/>
              </a:ext>
            </a:extLst>
          </p:cNvPr>
          <p:cNvSpPr txBox="1"/>
          <p:nvPr/>
        </p:nvSpPr>
        <p:spPr>
          <a:xfrm>
            <a:off x="844479" y="463739"/>
            <a:ext cx="217846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roportion of patients </a:t>
            </a: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ot requiring a platelet transfusion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BE25C15-BA9B-882C-5C42-B1BCC80F5949}"/>
              </a:ext>
            </a:extLst>
          </p:cNvPr>
          <p:cNvSpPr txBox="1"/>
          <p:nvPr/>
        </p:nvSpPr>
        <p:spPr>
          <a:xfrm>
            <a:off x="4077124" y="460495"/>
            <a:ext cx="227871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roportion of patients who achieved </a:t>
            </a: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latelet counts ≥50,000/µL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D7280DC-8D0E-F981-F95F-FD90B359D7C4}"/>
              </a:ext>
            </a:extLst>
          </p:cNvPr>
          <p:cNvSpPr txBox="1"/>
          <p:nvPr/>
        </p:nvSpPr>
        <p:spPr>
          <a:xfrm>
            <a:off x="936679" y="3265182"/>
            <a:ext cx="173772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agnitude of change in platelet count from baseline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90F23C15-FF6C-C916-0592-84610031A2B6}"/>
              </a:ext>
            </a:extLst>
          </p:cNvPr>
          <p:cNvGrpSpPr/>
          <p:nvPr/>
        </p:nvGrpSpPr>
        <p:grpSpPr>
          <a:xfrm>
            <a:off x="172765" y="1183967"/>
            <a:ext cx="2973600" cy="1759141"/>
            <a:chOff x="3488094" y="1251106"/>
            <a:chExt cx="3772800" cy="3697174"/>
          </a:xfrm>
        </p:grpSpPr>
        <p:graphicFrame>
          <p:nvGraphicFramePr>
            <p:cNvPr id="13" name="グラフ 12">
              <a:extLst>
                <a:ext uri="{FF2B5EF4-FFF2-40B4-BE49-F238E27FC236}">
                  <a16:creationId xmlns:a16="http://schemas.microsoft.com/office/drawing/2014/main" id="{5A89190B-F10C-8EB0-F71D-EE1D65D60CC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45057652"/>
                </p:ext>
              </p:extLst>
            </p:nvPr>
          </p:nvGraphicFramePr>
          <p:xfrm>
            <a:off x="3488094" y="1380680"/>
            <a:ext cx="3772800" cy="3567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D82714F7-47AF-E1A7-1893-2DE0520FD09A}"/>
                </a:ext>
              </a:extLst>
            </p:cNvPr>
            <p:cNvCxnSpPr/>
            <p:nvPr/>
          </p:nvCxnSpPr>
          <p:spPr>
            <a:xfrm>
              <a:off x="5125215" y="1251106"/>
              <a:ext cx="10287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テキスト ボックス 20">
              <a:extLst>
                <a:ext uri="{FF2B5EF4-FFF2-40B4-BE49-F238E27FC236}">
                  <a16:creationId xmlns:a16="http://schemas.microsoft.com/office/drawing/2014/main" id="{BC0324BC-592C-3A1F-A531-0FB4FD08F61D}"/>
                </a:ext>
              </a:extLst>
            </p:cNvPr>
            <p:cNvSpPr txBox="1"/>
            <p:nvPr/>
          </p:nvSpPr>
          <p:spPr>
            <a:xfrm>
              <a:off x="6074879" y="2011131"/>
              <a:ext cx="655788" cy="39967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0.6%</a:t>
              </a:r>
              <a:endParaRPr kumimoji="1" lang="ja-JP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763EF1AA-06D5-68D7-48F0-1BD93CD245B2}"/>
                </a:ext>
              </a:extLst>
            </p:cNvPr>
            <p:cNvSpPr txBox="1"/>
            <p:nvPr/>
          </p:nvSpPr>
          <p:spPr>
            <a:xfrm>
              <a:off x="4641703" y="1450113"/>
              <a:ext cx="655788" cy="38464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1.7</a:t>
              </a:r>
              <a:r>
                <a:rPr kumimoji="1" lang="en-US" altLang="ja-JP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</a:t>
              </a:r>
              <a:endParaRPr kumimoji="1" lang="ja-JP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6" name="グループ化 35">
            <a:extLst>
              <a:ext uri="{FF2B5EF4-FFF2-40B4-BE49-F238E27FC236}">
                <a16:creationId xmlns:a16="http://schemas.microsoft.com/office/drawing/2014/main" id="{65C754ED-9AFD-9155-6785-9EFA5A875D65}"/>
              </a:ext>
            </a:extLst>
          </p:cNvPr>
          <p:cNvGrpSpPr/>
          <p:nvPr/>
        </p:nvGrpSpPr>
        <p:grpSpPr>
          <a:xfrm>
            <a:off x="3429000" y="956165"/>
            <a:ext cx="2973600" cy="1984207"/>
            <a:chOff x="3482297" y="3714081"/>
            <a:chExt cx="2973600" cy="1984207"/>
          </a:xfrm>
        </p:grpSpPr>
        <p:grpSp>
          <p:nvGrpSpPr>
            <p:cNvPr id="34" name="グループ化 33">
              <a:extLst>
                <a:ext uri="{FF2B5EF4-FFF2-40B4-BE49-F238E27FC236}">
                  <a16:creationId xmlns:a16="http://schemas.microsoft.com/office/drawing/2014/main" id="{B5FA9846-912E-9593-CD90-F70484228E8A}"/>
                </a:ext>
              </a:extLst>
            </p:cNvPr>
            <p:cNvGrpSpPr/>
            <p:nvPr/>
          </p:nvGrpSpPr>
          <p:grpSpPr>
            <a:xfrm>
              <a:off x="3482297" y="3714081"/>
              <a:ext cx="2973600" cy="1984207"/>
              <a:chOff x="4040563" y="2001058"/>
              <a:chExt cx="3772800" cy="3953271"/>
            </a:xfrm>
          </p:grpSpPr>
          <p:graphicFrame>
            <p:nvGraphicFramePr>
              <p:cNvPr id="29" name="グラフ 28">
                <a:extLst>
                  <a:ext uri="{FF2B5EF4-FFF2-40B4-BE49-F238E27FC236}">
                    <a16:creationId xmlns:a16="http://schemas.microsoft.com/office/drawing/2014/main" id="{3D659D79-8EEB-CA41-2418-814C9F8EC1B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597002895"/>
                  </p:ext>
                </p:extLst>
              </p:nvPr>
            </p:nvGraphicFramePr>
            <p:xfrm>
              <a:off x="4040563" y="2386728"/>
              <a:ext cx="3772800" cy="356760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30" name="テキスト ボックス 20">
                <a:extLst>
                  <a:ext uri="{FF2B5EF4-FFF2-40B4-BE49-F238E27FC236}">
                    <a16:creationId xmlns:a16="http://schemas.microsoft.com/office/drawing/2014/main" id="{8125713A-959A-E9C7-7B89-70E449962367}"/>
                  </a:ext>
                </a:extLst>
              </p:cNvPr>
              <p:cNvSpPr txBox="1"/>
              <p:nvPr/>
            </p:nvSpPr>
            <p:spPr>
              <a:xfrm>
                <a:off x="5215488" y="2714937"/>
                <a:ext cx="628848" cy="391407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ja-JP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0.6%</a:t>
                </a:r>
                <a:endParaRPr kumimoji="1" lang="ja-JP" altLang="en-U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テキスト ボックス 20">
                <a:extLst>
                  <a:ext uri="{FF2B5EF4-FFF2-40B4-BE49-F238E27FC236}">
                    <a16:creationId xmlns:a16="http://schemas.microsoft.com/office/drawing/2014/main" id="{A13CA7E6-B7DE-0170-7B37-E767D4155455}"/>
                  </a:ext>
                </a:extLst>
              </p:cNvPr>
              <p:cNvSpPr txBox="1"/>
              <p:nvPr/>
            </p:nvSpPr>
            <p:spPr>
              <a:xfrm>
                <a:off x="6632050" y="3101761"/>
                <a:ext cx="628848" cy="391407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7.6</a:t>
                </a:r>
                <a:r>
                  <a:rPr kumimoji="1" lang="en-US" altLang="ja-JP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  <a:endParaRPr kumimoji="1" lang="ja-JP" altLang="en-U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テキスト ボックス 17">
                <a:extLst>
                  <a:ext uri="{FF2B5EF4-FFF2-40B4-BE49-F238E27FC236}">
                    <a16:creationId xmlns:a16="http://schemas.microsoft.com/office/drawing/2014/main" id="{87FAED75-8CE8-0B42-26D5-CC8BA049C1CA}"/>
                  </a:ext>
                </a:extLst>
              </p:cNvPr>
              <p:cNvSpPr txBox="1"/>
              <p:nvPr/>
            </p:nvSpPr>
            <p:spPr>
              <a:xfrm>
                <a:off x="5891931" y="2001058"/>
                <a:ext cx="738615" cy="196671"/>
              </a:xfrm>
              <a:prstGeom prst="rect">
                <a:avLst/>
              </a:prstGeom>
              <a:solidFill>
                <a:schemeClr val="lt1"/>
              </a:solidFill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=0.217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63EDA318-12D4-7F7D-C524-11FFBF116A44}"/>
                </a:ext>
              </a:extLst>
            </p:cNvPr>
            <p:cNvCxnSpPr/>
            <p:nvPr/>
          </p:nvCxnSpPr>
          <p:spPr>
            <a:xfrm>
              <a:off x="4903973" y="3942316"/>
              <a:ext cx="6690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グループ化 43">
            <a:extLst>
              <a:ext uri="{FF2B5EF4-FFF2-40B4-BE49-F238E27FC236}">
                <a16:creationId xmlns:a16="http://schemas.microsoft.com/office/drawing/2014/main" id="{D4207E9A-DD0A-7BBF-C802-73DC7D6C60E9}"/>
              </a:ext>
            </a:extLst>
          </p:cNvPr>
          <p:cNvGrpSpPr/>
          <p:nvPr/>
        </p:nvGrpSpPr>
        <p:grpSpPr>
          <a:xfrm>
            <a:off x="179294" y="3748285"/>
            <a:ext cx="2973600" cy="1985080"/>
            <a:chOff x="172765" y="6345105"/>
            <a:chExt cx="2973600" cy="1985080"/>
          </a:xfrm>
        </p:grpSpPr>
        <p:graphicFrame>
          <p:nvGraphicFramePr>
            <p:cNvPr id="37" name="グラフ 36">
              <a:extLst>
                <a:ext uri="{FF2B5EF4-FFF2-40B4-BE49-F238E27FC236}">
                  <a16:creationId xmlns:a16="http://schemas.microsoft.com/office/drawing/2014/main" id="{6005256A-EC4E-41F8-7327-55EF0891EAC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05286556"/>
                </p:ext>
              </p:extLst>
            </p:nvPr>
          </p:nvGraphicFramePr>
          <p:xfrm>
            <a:off x="172765" y="6436585"/>
            <a:ext cx="2973600" cy="1893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76665431-6E76-F67A-D70B-1884997E6393}"/>
                </a:ext>
              </a:extLst>
            </p:cNvPr>
            <p:cNvCxnSpPr/>
            <p:nvPr/>
          </p:nvCxnSpPr>
          <p:spPr>
            <a:xfrm>
              <a:off x="1659565" y="6562826"/>
              <a:ext cx="6690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テキスト ボックス 5">
              <a:extLst>
                <a:ext uri="{FF2B5EF4-FFF2-40B4-BE49-F238E27FC236}">
                  <a16:creationId xmlns:a16="http://schemas.microsoft.com/office/drawing/2014/main" id="{DB7E04A8-25C2-8354-8917-FC4404A68F50}"/>
                </a:ext>
              </a:extLst>
            </p:cNvPr>
            <p:cNvSpPr txBox="1"/>
            <p:nvPr/>
          </p:nvSpPr>
          <p:spPr>
            <a:xfrm>
              <a:off x="1690880" y="6345105"/>
              <a:ext cx="748425" cy="116532"/>
            </a:xfrm>
            <a:prstGeom prst="rect">
              <a:avLst/>
            </a:prstGeom>
            <a:solidFill>
              <a:schemeClr val="lt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=0.50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5A6917C-A369-AF4F-083E-D97207329F3A}"/>
              </a:ext>
            </a:extLst>
          </p:cNvPr>
          <p:cNvSpPr txBox="1"/>
          <p:nvPr/>
        </p:nvSpPr>
        <p:spPr>
          <a:xfrm>
            <a:off x="3122806" y="3299728"/>
            <a:ext cx="2057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463F6CB6-D1DE-8D6F-F54C-5D73C85BEF6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7477337"/>
              </p:ext>
            </p:extLst>
          </p:nvPr>
        </p:nvGraphicFramePr>
        <p:xfrm>
          <a:off x="3430889" y="3299258"/>
          <a:ext cx="3106800" cy="2318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350C22D-6144-9711-39FA-68D96E195EEF}"/>
              </a:ext>
            </a:extLst>
          </p:cNvPr>
          <p:cNvSpPr txBox="1"/>
          <p:nvPr/>
        </p:nvSpPr>
        <p:spPr>
          <a:xfrm>
            <a:off x="3932577" y="5304316"/>
            <a:ext cx="618308" cy="224478"/>
          </a:xfrm>
          <a:prstGeom prst="rect">
            <a:avLst/>
          </a:prstGeom>
          <a:solidFill>
            <a:schemeClr val="tx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sing</a:t>
            </a:r>
            <a:endParaRPr kumimoji="1" lang="ja-JP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5">
            <a:extLst>
              <a:ext uri="{FF2B5EF4-FFF2-40B4-BE49-F238E27FC236}">
                <a16:creationId xmlns:a16="http://schemas.microsoft.com/office/drawing/2014/main" id="{359BA2AD-5C2C-3E3B-68AB-F523EC7F574F}"/>
              </a:ext>
            </a:extLst>
          </p:cNvPr>
          <p:cNvSpPr txBox="1"/>
          <p:nvPr/>
        </p:nvSpPr>
        <p:spPr>
          <a:xfrm>
            <a:off x="3932669" y="5532372"/>
            <a:ext cx="515474" cy="284389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sit 2</a:t>
            </a:r>
          </a:p>
          <a:p>
            <a:r>
              <a:rPr kumimoji="1"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1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5">
            <a:extLst>
              <a:ext uri="{FF2B5EF4-FFF2-40B4-BE49-F238E27FC236}">
                <a16:creationId xmlns:a16="http://schemas.microsoft.com/office/drawing/2014/main" id="{AB99A4DE-4903-FD64-B29D-6E9FFC102EAB}"/>
              </a:ext>
            </a:extLst>
          </p:cNvPr>
          <p:cNvSpPr txBox="1"/>
          <p:nvPr/>
        </p:nvSpPr>
        <p:spPr>
          <a:xfrm>
            <a:off x="4421180" y="5535950"/>
            <a:ext cx="515473" cy="284389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sit 3</a:t>
            </a:r>
          </a:p>
          <a:p>
            <a:r>
              <a:rPr kumimoji="1"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5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5">
            <a:extLst>
              <a:ext uri="{FF2B5EF4-FFF2-40B4-BE49-F238E27FC236}">
                <a16:creationId xmlns:a16="http://schemas.microsoft.com/office/drawing/2014/main" id="{E252C7B8-DCD8-1903-027C-68DBAF2EAC55}"/>
              </a:ext>
            </a:extLst>
          </p:cNvPr>
          <p:cNvSpPr txBox="1"/>
          <p:nvPr/>
        </p:nvSpPr>
        <p:spPr>
          <a:xfrm>
            <a:off x="4985435" y="5532372"/>
            <a:ext cx="624305" cy="284389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sit 4</a:t>
            </a:r>
          </a:p>
          <a:p>
            <a:r>
              <a:rPr kumimoji="1"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8-13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5">
            <a:extLst>
              <a:ext uri="{FF2B5EF4-FFF2-40B4-BE49-F238E27FC236}">
                <a16:creationId xmlns:a16="http://schemas.microsoft.com/office/drawing/2014/main" id="{8C506677-AFF5-3D8F-1131-6A60480400E6}"/>
              </a:ext>
            </a:extLst>
          </p:cNvPr>
          <p:cNvSpPr txBox="1"/>
          <p:nvPr/>
        </p:nvSpPr>
        <p:spPr>
          <a:xfrm>
            <a:off x="5820805" y="5529249"/>
            <a:ext cx="707733" cy="284389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sit 5</a:t>
            </a:r>
          </a:p>
          <a:p>
            <a:r>
              <a:rPr kumimoji="1"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15-27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17">
            <a:extLst>
              <a:ext uri="{FF2B5EF4-FFF2-40B4-BE49-F238E27FC236}">
                <a16:creationId xmlns:a16="http://schemas.microsoft.com/office/drawing/2014/main" id="{5CFF66E3-4820-B94B-1493-D2D0D8A1516D}"/>
              </a:ext>
            </a:extLst>
          </p:cNvPr>
          <p:cNvSpPr txBox="1"/>
          <p:nvPr/>
        </p:nvSpPr>
        <p:spPr>
          <a:xfrm>
            <a:off x="1598874" y="950543"/>
            <a:ext cx="582153" cy="112187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0.02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03705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08</TotalTime>
  <Words>81</Words>
  <Application>Microsoft Office PowerPoint</Application>
  <PresentationFormat>A4 210 x 297 mm</PresentationFormat>
  <Paragraphs>3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UGA</dc:creator>
  <cp:lastModifiedBy>kakizaki satoru</cp:lastModifiedBy>
  <cp:revision>665</cp:revision>
  <cp:lastPrinted>2017-11-21T01:24:45Z</cp:lastPrinted>
  <dcterms:created xsi:type="dcterms:W3CDTF">2017-06-01T03:00:03Z</dcterms:created>
  <dcterms:modified xsi:type="dcterms:W3CDTF">2024-11-14T02:07:33Z</dcterms:modified>
</cp:coreProperties>
</file>